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9144000" cy="83327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0" d="100"/>
          <a:sy n="70" d="100"/>
        </p:scale>
        <p:origin x="1795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363723"/>
            <a:ext cx="7772400" cy="2901045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4376643"/>
            <a:ext cx="6858000" cy="2011828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dirty="0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25BF7-BAEB-47E4-AD2E-506FABD8B23A}" type="datetimeFigureOut">
              <a:rPr lang="ko-KR" altLang="en-US" smtClean="0"/>
              <a:t>2025-03-05-(Wed)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3B385-CB26-4603-9C74-E40189FF90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71513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25BF7-BAEB-47E4-AD2E-506FABD8B23A}" type="datetimeFigureOut">
              <a:rPr lang="ko-KR" altLang="en-US" smtClean="0"/>
              <a:t>2025-03-05-(Wed)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3B385-CB26-4603-9C74-E40189FF90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758545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443644"/>
            <a:ext cx="1971675" cy="7061653"/>
          </a:xfrm>
        </p:spPr>
        <p:txBody>
          <a:bodyPr vert="eaVert"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443644"/>
            <a:ext cx="5800725" cy="7061653"/>
          </a:xfrm>
        </p:spPr>
        <p:txBody>
          <a:bodyPr vert="eaVert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25BF7-BAEB-47E4-AD2E-506FABD8B23A}" type="datetimeFigureOut">
              <a:rPr lang="ko-KR" altLang="en-US" smtClean="0"/>
              <a:t>2025-03-05-(Wed)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3B385-CB26-4603-9C74-E40189FF90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984332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25BF7-BAEB-47E4-AD2E-506FABD8B23A}" type="datetimeFigureOut">
              <a:rPr lang="ko-KR" altLang="en-US" smtClean="0"/>
              <a:t>2025-03-05-(Wed)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3B385-CB26-4603-9C74-E40189FF90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85045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2077413"/>
            <a:ext cx="7886700" cy="3466208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5576412"/>
            <a:ext cx="7886700" cy="182279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25BF7-BAEB-47E4-AD2E-506FABD8B23A}" type="datetimeFigureOut">
              <a:rPr lang="ko-KR" altLang="en-US" smtClean="0"/>
              <a:t>2025-03-05-(Wed)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3B385-CB26-4603-9C74-E40189FF90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074758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2218219"/>
            <a:ext cx="3886200" cy="5287077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2218219"/>
            <a:ext cx="3886200" cy="5287077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25BF7-BAEB-47E4-AD2E-506FABD8B23A}" type="datetimeFigureOut">
              <a:rPr lang="ko-KR" altLang="en-US" smtClean="0"/>
              <a:t>2025-03-05-(Wed)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3B385-CB26-4603-9C74-E40189FF90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37854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43645"/>
            <a:ext cx="7886700" cy="1610621"/>
          </a:xfrm>
        </p:spPr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2042691"/>
            <a:ext cx="3868340" cy="100109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3043782"/>
            <a:ext cx="3868340" cy="447694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2042691"/>
            <a:ext cx="3887391" cy="100109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3043782"/>
            <a:ext cx="3887391" cy="447694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25BF7-BAEB-47E4-AD2E-506FABD8B23A}" type="datetimeFigureOut">
              <a:rPr lang="ko-KR" altLang="en-US" smtClean="0"/>
              <a:t>2025-03-05-(Wed)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3B385-CB26-4603-9C74-E40189FF90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32914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25BF7-BAEB-47E4-AD2E-506FABD8B23A}" type="datetimeFigureOut">
              <a:rPr lang="ko-KR" altLang="en-US" smtClean="0"/>
              <a:t>2025-03-05-(Wed)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3B385-CB26-4603-9C74-E40189FF90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328673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25BF7-BAEB-47E4-AD2E-506FABD8B23A}" type="datetimeFigureOut">
              <a:rPr lang="ko-KR" altLang="en-US" smtClean="0"/>
              <a:t>2025-03-05-(Wed)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3B385-CB26-4603-9C74-E40189FF90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163202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555519"/>
            <a:ext cx="2949178" cy="1944317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199769"/>
            <a:ext cx="4629150" cy="592168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499836"/>
            <a:ext cx="2949178" cy="463125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25BF7-BAEB-47E4-AD2E-506FABD8B23A}" type="datetimeFigureOut">
              <a:rPr lang="ko-KR" altLang="en-US" smtClean="0"/>
              <a:t>2025-03-05-(Wed)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3B385-CB26-4603-9C74-E40189FF90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07992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555519"/>
            <a:ext cx="2949178" cy="1944317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199769"/>
            <a:ext cx="4629150" cy="5921680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499836"/>
            <a:ext cx="2949178" cy="463125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25BF7-BAEB-47E4-AD2E-506FABD8B23A}" type="datetimeFigureOut">
              <a:rPr lang="ko-KR" altLang="en-US" smtClean="0"/>
              <a:t>2025-03-05-(Wed)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3B385-CB26-4603-9C74-E40189FF90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039213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443645"/>
            <a:ext cx="7886700" cy="16106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2218219"/>
            <a:ext cx="7886700" cy="528707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7723262"/>
            <a:ext cx="2057400" cy="4436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125BF7-BAEB-47E4-AD2E-506FABD8B23A}" type="datetimeFigureOut">
              <a:rPr lang="ko-KR" altLang="en-US" smtClean="0"/>
              <a:t>2025-03-05-(Wed)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7723262"/>
            <a:ext cx="3086100" cy="4436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7723262"/>
            <a:ext cx="2057400" cy="4436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F3B385-CB26-4603-9C74-E40189FF90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952077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0" name="Picture 6">
            <a:extLst>
              <a:ext uri="{FF2B5EF4-FFF2-40B4-BE49-F238E27FC236}">
                <a16:creationId xmlns:a16="http://schemas.microsoft.com/office/drawing/2014/main" id="{3AE58D41-A36B-A738-6D6B-35807915940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60590" y="737394"/>
            <a:ext cx="4821237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직사각형 2"/>
          <p:cNvSpPr/>
          <p:nvPr/>
        </p:nvSpPr>
        <p:spPr>
          <a:xfrm>
            <a:off x="1174106" y="213277"/>
            <a:ext cx="7091914" cy="5241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2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2.</a:t>
            </a:r>
            <a:r>
              <a:rPr lang="en-US" sz="1200" b="0" i="0" dirty="0">
                <a:solidFill>
                  <a:srgbClr val="0D0D0D"/>
                </a:solidFill>
                <a:effectLst/>
                <a:latin typeface="Söhne"/>
              </a:rPr>
              <a:t> Flowchart of Patient Selection and Stratification for additional analysis on mortality</a:t>
            </a:r>
          </a:p>
          <a:p>
            <a:r>
              <a:rPr lang="en-US" altLang="ko-KR" sz="11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*Landmark analysis excluded patients with death, loss to follow-up from diagnosis</a:t>
            </a:r>
          </a:p>
          <a:p>
            <a:endParaRPr lang="ko-KR" altLang="en-US" sz="1200" dirty="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134968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1</TotalTime>
  <Words>28</Words>
  <Application>Microsoft Office PowerPoint</Application>
  <PresentationFormat>사용자 지정</PresentationFormat>
  <Paragraphs>2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Söhne</vt:lpstr>
      <vt:lpstr>Arial</vt:lpstr>
      <vt:lpstr>Calibri</vt:lpstr>
      <vt:lpstr>Calibri Light</vt:lpstr>
      <vt:lpstr>Office 2013 - 2022 Theme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하정훈</dc:creator>
  <cp:lastModifiedBy>Jeonghoon Ha</cp:lastModifiedBy>
  <cp:revision>5</cp:revision>
  <dcterms:created xsi:type="dcterms:W3CDTF">2023-10-10T01:53:00Z</dcterms:created>
  <dcterms:modified xsi:type="dcterms:W3CDTF">2025-03-06T04:13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Fasoo_Trace_ID">
    <vt:lpwstr>eyJub2RlMSI6eyJkc2QiOiIwMDAwMDAwMDAwMDAwMDAwIiwibG9nVGltZSI6IjIwMjMtMTAtMTNUMDM6MDk6NDRaIiwicElEIjoyMDQ4LCJ0cmFjZUlkIjoiRDY5NzI5QUQ0MDkwNDRGQ0FBQUYxQUU2REY4MkM0MkUiLCJ1c2VyQ29kZSI6IjIxMTAwNDAxIn0sIm5vZGUyIjp7ImRzZCI6IjAxMDAwMDAwMDAwMDMxOTQiLCJsb2dUaW1lIjoiMjAyMy0xMS0wN1QwMjozMTo0OVoiLCJwSUQiOjEsInRyYWNlSWQiOiI1NEQ1OTk4RjdEQTY0MzQ0QkIxQ0UxNEVBOTFCNzQwNyIsInVzZXJDb2RlIjoiMjExMDA0MDEifSwibm9kZTMiOnsiZHNkIjoiMDAwMDAwMDAwMDAwMDAwMCIsImxvZ1RpbWUiOiIyMDIzLTExLTE2VDA1OjAyOjM1WiIsInBJRCI6MjA0OCwidHJhY2VJZCI6IkMyN0E3MzQ0MzYzMTRGMzJBMUMwNDE3M0ZFODhBRjVFIiwidXNlckNvZGUiOiIyMTEwMDQwMSJ9LCJub2RlNCI6eyJkc2QiOiIwMTAwMDAwMDAwMDAzMTk0IiwibG9nVGltZSI6IjIwMjMtMTEtMTZUMjI6MzU6MzdaIiwicElEIjoxLCJ0cmFjZUlkIjoiOTQ0NDJFNEYxQjJCNERCRjk2RUJERTI4ODNFNEY1ODQiLCJ1c2VyQ29kZSI6IjIxMTAwNDAxIn0sIm5vZGU1Ijp7ImRzZCI6IjAwMDAwMDAwMDAwMDAwMDAiLCJsb2dUaW1lIjoiMjAyMy0xMS0xNlQyMzowMzo0NloiLCJwSUQiOjIwNDgsInRyYWNlSWQiOiJERDY4NDQ0MkY4N0U0Njg2QUYzRTcwRkEzRUM4QzM5OSIsInVzZXJDb2RlIjoiMjExMDA0MDEifSwibm9kZUNvdW50Ijo2fQ==</vt:lpwstr>
  </property>
</Properties>
</file>